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5715000" type="screen16x1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80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2083" autoAdjust="0"/>
  </p:normalViewPr>
  <p:slideViewPr>
    <p:cSldViewPr snapToGrid="0" snapToObjects="1">
      <p:cViewPr>
        <p:scale>
          <a:sx n="112" d="100"/>
          <a:sy n="112" d="100"/>
        </p:scale>
        <p:origin x="-344" y="64"/>
      </p:cViewPr>
      <p:guideLst>
        <p:guide orient="horz" pos="180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26A6AC-1961-4848-8C48-7A978FC7B1E9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685800"/>
            <a:ext cx="54864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D1D0BB-B543-1642-95D6-95A38AAE3A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15029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smtClean="0"/>
              <a:t>Table </a:t>
            </a:r>
            <a:r>
              <a:rPr lang="fr-FR" smtClean="0"/>
              <a:t>SI2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D1D0BB-B543-1642-95D6-95A38AAE3AC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72918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775357"/>
            <a:ext cx="7772400" cy="122502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238500"/>
            <a:ext cx="6400800" cy="14605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421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578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28867"/>
            <a:ext cx="2057400" cy="487627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28867"/>
            <a:ext cx="6019800" cy="487627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7570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0506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672418"/>
            <a:ext cx="7772400" cy="113506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422261"/>
            <a:ext cx="7772400" cy="125015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2822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33501"/>
            <a:ext cx="4038600" cy="37716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33501"/>
            <a:ext cx="4038600" cy="37716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4236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79261"/>
            <a:ext cx="4040188" cy="53313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12396"/>
            <a:ext cx="4040188" cy="329274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1" y="1279261"/>
            <a:ext cx="4041775" cy="53313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1" y="1812396"/>
            <a:ext cx="4041775" cy="329274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8022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1721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0671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6" y="227541"/>
            <a:ext cx="3008313" cy="96837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27545"/>
            <a:ext cx="5111750" cy="487759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6" y="1195920"/>
            <a:ext cx="3008313" cy="39092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3443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000501"/>
            <a:ext cx="5486400" cy="47228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510646"/>
            <a:ext cx="5486400" cy="34290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472784"/>
            <a:ext cx="5486400" cy="6707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5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28866"/>
            <a:ext cx="8229600" cy="9525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33501"/>
            <a:ext cx="8229600" cy="37716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5296960"/>
            <a:ext cx="21336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1CF847-24C5-1741-83DC-8947CFF08B65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5296960"/>
            <a:ext cx="28956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5296960"/>
            <a:ext cx="21336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65CFAB-5818-1C40-8BEF-398163D4DB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640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1944573"/>
              </p:ext>
            </p:extLst>
          </p:nvPr>
        </p:nvGraphicFramePr>
        <p:xfrm>
          <a:off x="140031" y="343116"/>
          <a:ext cx="4376136" cy="3454302"/>
        </p:xfrm>
        <a:graphic>
          <a:graphicData uri="http://schemas.openxmlformats.org/drawingml/2006/table">
            <a:tbl>
              <a:tblPr/>
              <a:tblGrid>
                <a:gridCol w="1227066"/>
                <a:gridCol w="961002"/>
                <a:gridCol w="1094034"/>
                <a:gridCol w="1094034"/>
              </a:tblGrid>
              <a:tr h="531174"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</a:t>
                      </a:r>
                    </a:p>
                  </a:txBody>
                  <a:tcPr marL="12700" marR="12700" marT="1058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-methylTHF (%)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,10-methenylTHF (%)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-formylTHF (%)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7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98G ML+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7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98G TS+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,05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1,7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,93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1,7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7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N299 ML+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7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N299 TS+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,39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0,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7,61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4,7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4,03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1,9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7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87 ML+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7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87 TS+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8,20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6,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7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251 ML+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7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251 TS+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,14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1,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,23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0,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,75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0,8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OMM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LEE ML+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6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OMM LEE TS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+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79,27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6,7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0,06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2,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6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BM cell lines average ML+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6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BM cell lines </a:t>
                      </a:r>
                      <a:r>
                        <a:rPr lang="en-US" sz="12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veragaged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TS+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,07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3,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,67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3,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6,04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3,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0618480"/>
              </p:ext>
            </p:extLst>
          </p:nvPr>
        </p:nvGraphicFramePr>
        <p:xfrm>
          <a:off x="4661655" y="343116"/>
          <a:ext cx="4357605" cy="3429419"/>
        </p:xfrm>
        <a:graphic>
          <a:graphicData uri="http://schemas.openxmlformats.org/drawingml/2006/table">
            <a:tbl>
              <a:tblPr/>
              <a:tblGrid>
                <a:gridCol w="1394559"/>
                <a:gridCol w="905850"/>
                <a:gridCol w="1028598"/>
                <a:gridCol w="1028598"/>
              </a:tblGrid>
              <a:tr h="4707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-methylTHF (%) 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,10-methenylTHF (%)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-formylTHF (%)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98G ML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98G TS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,83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2,3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,46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5,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N299 ML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N299 TS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2,48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1,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1,41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6,8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,31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2,8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87 ML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87 TS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9,31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9,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251 ML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251 TS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4,24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3,6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,64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1,0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9,57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1,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114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OMM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LEE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L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9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OMM LEE TS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</a:t>
                      </a: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6,48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6,1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8,53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1,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9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BM cell lines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verage ML-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9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BM cell lines averaged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TS-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4,84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6,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7,75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7,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9,19 </a:t>
                      </a:r>
                      <a:r>
                        <a:rPr kumimoji="0" lang="fi-FI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± 8,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058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66592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2</TotalTime>
  <Words>257</Words>
  <Application>Microsoft Macintosh PowerPoint</Application>
  <PresentationFormat>Présentation à l'écran (16:10)</PresentationFormat>
  <Paragraphs>106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a Zgheib</dc:creator>
  <cp:lastModifiedBy>F Namour</cp:lastModifiedBy>
  <cp:revision>48</cp:revision>
  <dcterms:created xsi:type="dcterms:W3CDTF">2019-04-16T19:26:55Z</dcterms:created>
  <dcterms:modified xsi:type="dcterms:W3CDTF">2019-04-29T08:59:30Z</dcterms:modified>
</cp:coreProperties>
</file>